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embeddings/oleObject7.bin" ContentType="application/vnd.openxmlformats-officedocument.oleObject"/>
  <Override PartName="/ppt/embeddings/oleObject8.bin" ContentType="application/vnd.openxmlformats-officedocument.oleObject"/>
  <Override PartName="/ppt/embeddings/oleObject9.bin" ContentType="application/vnd.openxmlformats-officedocument.oleObject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6.wmf" ContentType="image/x-wmf"/>
  <Override PartName="/ppt/media/image7.wmf" ContentType="image/x-wmf"/>
  <Override PartName="/ppt/media/image8.wmf" ContentType="image/x-wmf"/>
  <Override PartName="/ppt/media/image9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17280" y="744120"/>
            <a:ext cx="4962600" cy="3722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292DDDA-EF93-4867-A686-4A3BAD7C7D2C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PlaceHolder 1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62600" cy="3722760"/>
          </a:xfrm>
          <a:prstGeom prst="rect">
            <a:avLst/>
          </a:prstGeom>
          <a:ln w="0">
            <a:noFill/>
          </a:ln>
        </p:spPr>
      </p:sp>
      <p:sp>
        <p:nvSpPr>
          <p:cNvPr id="136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lnSpc>
                <a:spcPct val="115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4f81bd"/>
                </a:solidFill>
                <a:latin typeface="Arial"/>
                <a:ea typeface="SimSun"/>
              </a:rPr>
              <a:t>Figure E3. </a:t>
            </a:r>
            <a:r>
              <a:rPr b="0" lang="en-GB" sz="1200" spc="-1" strike="noStrike">
                <a:solidFill>
                  <a:srgbClr val="4f81bd"/>
                </a:solidFill>
                <a:latin typeface="Arial"/>
                <a:ea typeface="SimSun"/>
              </a:rPr>
              <a:t>Major CD4+ T cell subsets stratified by disease severit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 algn="just">
              <a:lnSpc>
                <a:spcPct val="115000"/>
              </a:lnSpc>
              <a:spcAft>
                <a:spcPts val="1001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(a)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 Ratios of CD3+4+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T cells expressing IL-13 (T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PMingLiU"/>
              </a:rPr>
              <a:t>h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2 cells), to those expressing IFN-γ (T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PMingLiU"/>
              </a:rPr>
              <a:t>h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1 cells) and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(b)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frequencies of CD3+4+ T cells expressing IFN-</a:t>
            </a:r>
            <a:r>
              <a:rPr b="0" lang="el-GR" sz="1200" spc="-1" strike="noStrike">
                <a:solidFill>
                  <a:srgbClr val="000000"/>
                </a:solidFill>
                <a:latin typeface="Arial"/>
                <a:ea typeface="SimSun"/>
              </a:rPr>
              <a:t>γ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 (T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PMingLiU"/>
              </a:rPr>
              <a:t>h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1 cells) in PBMC, sputum, BAL and bronchial biopsies measured by intracellular cytokine staining and flow cytometry. Results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are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expressed as a percentage of live CD3+CD4+ T cells, or for bronchial biopsies, as a percentage of CD3+8- T cells.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Medians are shown as horizontal lines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. Left hand column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of panels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shows healthy controls compared with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asthmatics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, and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P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 values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are from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 Mann-Whitney U tests. Right three columns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of panels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 show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the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same data stratified by disease severity (defined at enrolment) where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P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 values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are from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 Kruskal-Wallis tests and are given where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P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&lt;0.05. Significance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post hoc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 by Dunn’s compared with health: *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P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&lt;0.05, **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P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&lt;0.01. †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P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&lt;0.05 mild compared with severe asthma.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PMingLiU"/>
              </a:rPr>
              <a:t> 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healthy control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PMingLiU"/>
              </a:rPr>
              <a:t>;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mild asthma;  moderate asthma;  severe asthma.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PMingLiU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SimSun"/>
              </a:rPr>
              <a:t>Abbreviations: BAL, bronchoalveolar-lavage, PBMC, peripheral blood mononuclear cell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PMingLiU"/>
              </a:rPr>
              <a:t>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Slide Number Placeholder 3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94F3B89-EBFB-4B33-ADE1-0B31F197AC1F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0F04CC-EFF0-4D8E-9D7C-40AFAF50783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511B65-EEFF-4D0B-B21C-9D6DBFB9BE6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713703-3397-4BCA-AE65-72033657E04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5CAA79-D4E4-4366-A603-76507098BE5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4903FE-B7D7-4754-8C3D-38F65FC8FD3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584B04-45F4-4900-B784-0E63150B80C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F48D1D-41E5-4630-8505-0AA598722FA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754FD8-AF7D-40E2-85AF-BD48C0120D3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11E662-1797-4967-8C83-B603835747D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4E3A81-F800-4755-9B30-DFFFEBC4A9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CE0E17-6A7B-4519-81BA-CFB50B5200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1EBE6F-5BCE-45C7-BAE6-164DD96247A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EE19947-DF91-4EA6-91E0-E9C4991F9A2A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wmf"/><Relationship Id="rId9" Type="http://schemas.openxmlformats.org/officeDocument/2006/relationships/oleObject" Target="../embeddings/oleObject5.bin"/><Relationship Id="rId10" Type="http://schemas.openxmlformats.org/officeDocument/2006/relationships/image" Target="../media/image5.wmf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6.wmf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7.wmf"/><Relationship Id="rId15" Type="http://schemas.openxmlformats.org/officeDocument/2006/relationships/oleObject" Target="../embeddings/oleObject8.bin"/><Relationship Id="rId16" Type="http://schemas.openxmlformats.org/officeDocument/2006/relationships/image" Target="../media/image8.wmf"/><Relationship Id="rId17" Type="http://schemas.openxmlformats.org/officeDocument/2006/relationships/oleObject" Target="../embeddings/oleObject9.bin"/><Relationship Id="rId18" Type="http://schemas.openxmlformats.org/officeDocument/2006/relationships/image" Target="../media/image9.wmf"/><Relationship Id="rId19" Type="http://schemas.openxmlformats.org/officeDocument/2006/relationships/slideLayout" Target="../slideLayouts/slideLayout1.xml"/><Relationship Id="rId20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14"/>
          <p:cNvSpPr/>
          <p:nvPr/>
        </p:nvSpPr>
        <p:spPr>
          <a:xfrm>
            <a:off x="2386080" y="658800"/>
            <a:ext cx="828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Healt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14"/>
          <p:cNvSpPr/>
          <p:nvPr/>
        </p:nvSpPr>
        <p:spPr>
          <a:xfrm>
            <a:off x="2379600" y="771480"/>
            <a:ext cx="828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Asthm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0" name="Object 953"/>
          <p:cNvGraphicFramePr/>
          <p:nvPr/>
        </p:nvGraphicFramePr>
        <p:xfrm>
          <a:off x="160200" y="606600"/>
          <a:ext cx="2455920" cy="14810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51" name="Object 953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60200" y="606600"/>
                    <a:ext cx="2455920" cy="1481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2" name="Text Box 95"/>
          <p:cNvSpPr/>
          <p:nvPr/>
        </p:nvSpPr>
        <p:spPr>
          <a:xfrm rot="16200000">
            <a:off x="-486720" y="1267560"/>
            <a:ext cx="1263240" cy="23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Ratio of T</a:t>
            </a:r>
            <a:r>
              <a:rPr b="0" lang="en-GB" sz="8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H</a:t>
            </a: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2 to T</a:t>
            </a:r>
            <a:r>
              <a:rPr b="0" lang="en-GB" sz="8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H</a:t>
            </a: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1 cell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96"/>
          <p:cNvSpPr/>
          <p:nvPr/>
        </p:nvSpPr>
        <p:spPr>
          <a:xfrm>
            <a:off x="1658520" y="415800"/>
            <a:ext cx="650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P=0</a:t>
            </a: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.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00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14"/>
          <p:cNvSpPr/>
          <p:nvPr/>
        </p:nvSpPr>
        <p:spPr>
          <a:xfrm>
            <a:off x="19080" y="272880"/>
            <a:ext cx="4689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A . Th2 to Th1 Rati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96"/>
          <p:cNvSpPr/>
          <p:nvPr/>
        </p:nvSpPr>
        <p:spPr>
          <a:xfrm>
            <a:off x="387000" y="2060640"/>
            <a:ext cx="545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PBM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96"/>
          <p:cNvSpPr/>
          <p:nvPr/>
        </p:nvSpPr>
        <p:spPr>
          <a:xfrm>
            <a:off x="837720" y="2062080"/>
            <a:ext cx="615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Sput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96"/>
          <p:cNvSpPr/>
          <p:nvPr/>
        </p:nvSpPr>
        <p:spPr>
          <a:xfrm>
            <a:off x="1305360" y="2062080"/>
            <a:ext cx="418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BA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96"/>
          <p:cNvSpPr/>
          <p:nvPr/>
        </p:nvSpPr>
        <p:spPr>
          <a:xfrm>
            <a:off x="1718640" y="2062080"/>
            <a:ext cx="560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Biops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Straight Connector 64"/>
          <p:cNvSpPr/>
          <p:nvPr/>
        </p:nvSpPr>
        <p:spPr>
          <a:xfrm>
            <a:off x="865080" y="1990800"/>
            <a:ext cx="0" cy="69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Straight Connector 65"/>
          <p:cNvSpPr/>
          <p:nvPr/>
        </p:nvSpPr>
        <p:spPr>
          <a:xfrm>
            <a:off x="1319040" y="1990800"/>
            <a:ext cx="0" cy="69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Straight Connector 66"/>
          <p:cNvSpPr/>
          <p:nvPr/>
        </p:nvSpPr>
        <p:spPr>
          <a:xfrm>
            <a:off x="1768320" y="1990800"/>
            <a:ext cx="0" cy="69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95"/>
          <p:cNvSpPr/>
          <p:nvPr/>
        </p:nvSpPr>
        <p:spPr>
          <a:xfrm rot="16200000">
            <a:off x="2284560" y="1258560"/>
            <a:ext cx="1339920" cy="23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Ratio of T</a:t>
            </a:r>
            <a:r>
              <a:rPr b="0" lang="en-GB" sz="8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H</a:t>
            </a: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2 to T</a:t>
            </a:r>
            <a:r>
              <a:rPr b="0" lang="en-GB" sz="8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H</a:t>
            </a: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1 cell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96"/>
          <p:cNvSpPr/>
          <p:nvPr/>
        </p:nvSpPr>
        <p:spPr>
          <a:xfrm>
            <a:off x="3540960" y="503280"/>
            <a:ext cx="1127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ANOVA P=0</a:t>
            </a: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.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04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96"/>
          <p:cNvSpPr/>
          <p:nvPr/>
        </p:nvSpPr>
        <p:spPr>
          <a:xfrm>
            <a:off x="5626800" y="492120"/>
            <a:ext cx="1056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ANOVA P=0</a:t>
            </a: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.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0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96"/>
          <p:cNvSpPr/>
          <p:nvPr/>
        </p:nvSpPr>
        <p:spPr>
          <a:xfrm>
            <a:off x="7642800" y="501480"/>
            <a:ext cx="1127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ANOVA P=0</a:t>
            </a: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.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00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6" name="Object 954"/>
          <p:cNvGraphicFramePr/>
          <p:nvPr/>
        </p:nvGraphicFramePr>
        <p:xfrm>
          <a:off x="3011400" y="708120"/>
          <a:ext cx="2021040" cy="140004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67" name="Object 954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011400" y="708120"/>
                    <a:ext cx="2021040" cy="1400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8" name="Object 955"/>
          <p:cNvGraphicFramePr/>
          <p:nvPr/>
        </p:nvGraphicFramePr>
        <p:xfrm>
          <a:off x="5027760" y="712800"/>
          <a:ext cx="2019240" cy="140004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69" name="Object 955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5027760" y="712800"/>
                    <a:ext cx="2019240" cy="1400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70" name="Object 956"/>
          <p:cNvGraphicFramePr/>
          <p:nvPr/>
        </p:nvGraphicFramePr>
        <p:xfrm>
          <a:off x="7089840" y="728640"/>
          <a:ext cx="2020680" cy="140004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71" name="Object 956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7089840" y="728640"/>
                    <a:ext cx="2020680" cy="1400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72" name="Text Box 96"/>
          <p:cNvSpPr/>
          <p:nvPr/>
        </p:nvSpPr>
        <p:spPr>
          <a:xfrm>
            <a:off x="3774600" y="260280"/>
            <a:ext cx="615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Sput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96"/>
          <p:cNvSpPr/>
          <p:nvPr/>
        </p:nvSpPr>
        <p:spPr>
          <a:xfrm>
            <a:off x="5978880" y="260280"/>
            <a:ext cx="418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BA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96"/>
          <p:cNvSpPr/>
          <p:nvPr/>
        </p:nvSpPr>
        <p:spPr>
          <a:xfrm>
            <a:off x="7956720" y="260280"/>
            <a:ext cx="560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Biops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14"/>
          <p:cNvSpPr/>
          <p:nvPr/>
        </p:nvSpPr>
        <p:spPr>
          <a:xfrm>
            <a:off x="49320" y="2554200"/>
            <a:ext cx="2960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B.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Th1 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96"/>
          <p:cNvSpPr/>
          <p:nvPr/>
        </p:nvSpPr>
        <p:spPr>
          <a:xfrm>
            <a:off x="3784320" y="2720880"/>
            <a:ext cx="615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Sput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96"/>
          <p:cNvSpPr/>
          <p:nvPr/>
        </p:nvSpPr>
        <p:spPr>
          <a:xfrm>
            <a:off x="5988240" y="2720880"/>
            <a:ext cx="418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BA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96"/>
          <p:cNvSpPr/>
          <p:nvPr/>
        </p:nvSpPr>
        <p:spPr>
          <a:xfrm>
            <a:off x="7966080" y="2720880"/>
            <a:ext cx="560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Biops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96"/>
          <p:cNvSpPr/>
          <p:nvPr/>
        </p:nvSpPr>
        <p:spPr>
          <a:xfrm>
            <a:off x="5195160" y="2023920"/>
            <a:ext cx="60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Health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96"/>
          <p:cNvSpPr/>
          <p:nvPr/>
        </p:nvSpPr>
        <p:spPr>
          <a:xfrm>
            <a:off x="5758560" y="2025720"/>
            <a:ext cx="41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il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96"/>
          <p:cNvSpPr/>
          <p:nvPr/>
        </p:nvSpPr>
        <p:spPr>
          <a:xfrm>
            <a:off x="6148800" y="202572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od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96"/>
          <p:cNvSpPr/>
          <p:nvPr/>
        </p:nvSpPr>
        <p:spPr>
          <a:xfrm>
            <a:off x="6504480" y="2025720"/>
            <a:ext cx="58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Sever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96"/>
          <p:cNvSpPr/>
          <p:nvPr/>
        </p:nvSpPr>
        <p:spPr>
          <a:xfrm>
            <a:off x="7239960" y="2028960"/>
            <a:ext cx="60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Health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96"/>
          <p:cNvSpPr/>
          <p:nvPr/>
        </p:nvSpPr>
        <p:spPr>
          <a:xfrm>
            <a:off x="7804440" y="2030400"/>
            <a:ext cx="41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il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96"/>
          <p:cNvSpPr/>
          <p:nvPr/>
        </p:nvSpPr>
        <p:spPr>
          <a:xfrm>
            <a:off x="8193600" y="203040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od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 Box 96"/>
          <p:cNvSpPr/>
          <p:nvPr/>
        </p:nvSpPr>
        <p:spPr>
          <a:xfrm>
            <a:off x="8550720" y="2030400"/>
            <a:ext cx="58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Sever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96"/>
          <p:cNvSpPr/>
          <p:nvPr/>
        </p:nvSpPr>
        <p:spPr>
          <a:xfrm>
            <a:off x="3185280" y="2028960"/>
            <a:ext cx="60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Health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96"/>
          <p:cNvSpPr/>
          <p:nvPr/>
        </p:nvSpPr>
        <p:spPr>
          <a:xfrm>
            <a:off x="3749760" y="2030400"/>
            <a:ext cx="41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il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96"/>
          <p:cNvSpPr/>
          <p:nvPr/>
        </p:nvSpPr>
        <p:spPr>
          <a:xfrm>
            <a:off x="4138920" y="203040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od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96"/>
          <p:cNvSpPr/>
          <p:nvPr/>
        </p:nvSpPr>
        <p:spPr>
          <a:xfrm>
            <a:off x="4495680" y="2030400"/>
            <a:ext cx="58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Sever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91" name="Object 2"/>
          <p:cNvGraphicFramePr/>
          <p:nvPr/>
        </p:nvGraphicFramePr>
        <p:xfrm>
          <a:off x="5027760" y="712800"/>
          <a:ext cx="2019240" cy="139860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92" name="Object 2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5027760" y="712800"/>
                    <a:ext cx="2019240" cy="1398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93" name="Object 3"/>
          <p:cNvGraphicFramePr/>
          <p:nvPr/>
        </p:nvGraphicFramePr>
        <p:xfrm>
          <a:off x="3011400" y="708120"/>
          <a:ext cx="2021040" cy="1400040"/>
        </p:xfrm>
        <a:graphic>
          <a:graphicData uri="http://schemas.openxmlformats.org/presentationml/2006/ole">
            <p:oleObj r:id="rId11" spid="">
              <p:embed/>
              <p:pic>
                <p:nvPicPr>
                  <p:cNvPr id="94" name="Object 3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3011400" y="708120"/>
                    <a:ext cx="2021040" cy="1400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95" name="Object 4"/>
          <p:cNvGraphicFramePr/>
          <p:nvPr/>
        </p:nvGraphicFramePr>
        <p:xfrm>
          <a:off x="7089840" y="728640"/>
          <a:ext cx="2020680" cy="1400040"/>
        </p:xfrm>
        <a:graphic>
          <a:graphicData uri="http://schemas.openxmlformats.org/presentationml/2006/ole">
            <p:oleObj r:id="rId13" spid="">
              <p:embed/>
              <p:pic>
                <p:nvPicPr>
                  <p:cNvPr id="96" name="Object 4" descr=""/>
                  <p:cNvPicPr/>
                  <p:nvPr/>
                </p:nvPicPr>
                <p:blipFill>
                  <a:blip r:embed="rId14"/>
                  <a:stretch/>
                </p:blipFill>
                <p:spPr>
                  <a:xfrm>
                    <a:off x="7089840" y="728640"/>
                    <a:ext cx="2020680" cy="1400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97" name="Object 1"/>
          <p:cNvGraphicFramePr/>
          <p:nvPr/>
        </p:nvGraphicFramePr>
        <p:xfrm>
          <a:off x="250920" y="2928960"/>
          <a:ext cx="2211120" cy="1308240"/>
        </p:xfrm>
        <a:graphic>
          <a:graphicData uri="http://schemas.openxmlformats.org/presentationml/2006/ole">
            <p:oleObj r:id="rId15" spid="">
              <p:embed/>
              <p:pic>
                <p:nvPicPr>
                  <p:cNvPr id="98" name="Object 1" descr=""/>
                  <p:cNvPicPr/>
                  <p:nvPr/>
                </p:nvPicPr>
                <p:blipFill>
                  <a:blip r:embed="rId16"/>
                  <a:stretch/>
                </p:blipFill>
                <p:spPr>
                  <a:xfrm>
                    <a:off x="250920" y="2928960"/>
                    <a:ext cx="2211120" cy="13082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99" name="Text Box 95"/>
          <p:cNvSpPr/>
          <p:nvPr/>
        </p:nvSpPr>
        <p:spPr>
          <a:xfrm rot="16200000">
            <a:off x="2206800" y="3409560"/>
            <a:ext cx="1340640" cy="353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T</a:t>
            </a:r>
            <a:r>
              <a:rPr b="0" lang="en-GB" sz="8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H</a:t>
            </a: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1 cell frequencie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(% CD4+ or CD8- T cells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 Box 96"/>
          <p:cNvSpPr/>
          <p:nvPr/>
        </p:nvSpPr>
        <p:spPr>
          <a:xfrm>
            <a:off x="3784320" y="2720880"/>
            <a:ext cx="615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Sput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 Box 96"/>
          <p:cNvSpPr/>
          <p:nvPr/>
        </p:nvSpPr>
        <p:spPr>
          <a:xfrm>
            <a:off x="5988240" y="2720880"/>
            <a:ext cx="418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BA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 Box 96"/>
          <p:cNvSpPr/>
          <p:nvPr/>
        </p:nvSpPr>
        <p:spPr>
          <a:xfrm>
            <a:off x="7966080" y="2720880"/>
            <a:ext cx="560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Biops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 Box 96"/>
          <p:cNvSpPr/>
          <p:nvPr/>
        </p:nvSpPr>
        <p:spPr>
          <a:xfrm>
            <a:off x="5190480" y="4257720"/>
            <a:ext cx="60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Health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 Box 96"/>
          <p:cNvSpPr/>
          <p:nvPr/>
        </p:nvSpPr>
        <p:spPr>
          <a:xfrm>
            <a:off x="5754960" y="4257720"/>
            <a:ext cx="41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il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 Box 96"/>
          <p:cNvSpPr/>
          <p:nvPr/>
        </p:nvSpPr>
        <p:spPr>
          <a:xfrm>
            <a:off x="6144120" y="425772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od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 Box 96"/>
          <p:cNvSpPr/>
          <p:nvPr/>
        </p:nvSpPr>
        <p:spPr>
          <a:xfrm>
            <a:off x="6500520" y="4257720"/>
            <a:ext cx="58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Sever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 Box 96"/>
          <p:cNvSpPr/>
          <p:nvPr/>
        </p:nvSpPr>
        <p:spPr>
          <a:xfrm>
            <a:off x="7235280" y="4262400"/>
            <a:ext cx="60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Health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 Box 96"/>
          <p:cNvSpPr/>
          <p:nvPr/>
        </p:nvSpPr>
        <p:spPr>
          <a:xfrm>
            <a:off x="7799400" y="4262400"/>
            <a:ext cx="41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il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 Box 96"/>
          <p:cNvSpPr/>
          <p:nvPr/>
        </p:nvSpPr>
        <p:spPr>
          <a:xfrm>
            <a:off x="8188560" y="426240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od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 Box 96"/>
          <p:cNvSpPr/>
          <p:nvPr/>
        </p:nvSpPr>
        <p:spPr>
          <a:xfrm>
            <a:off x="8546040" y="4262400"/>
            <a:ext cx="58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Sever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 Box 96"/>
          <p:cNvSpPr/>
          <p:nvPr/>
        </p:nvSpPr>
        <p:spPr>
          <a:xfrm>
            <a:off x="3180600" y="4262400"/>
            <a:ext cx="60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Health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 Box 96"/>
          <p:cNvSpPr/>
          <p:nvPr/>
        </p:nvSpPr>
        <p:spPr>
          <a:xfrm>
            <a:off x="3745080" y="4262400"/>
            <a:ext cx="41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il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Text Box 96"/>
          <p:cNvSpPr/>
          <p:nvPr/>
        </p:nvSpPr>
        <p:spPr>
          <a:xfrm>
            <a:off x="4134240" y="426240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od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Text Box 96"/>
          <p:cNvSpPr/>
          <p:nvPr/>
        </p:nvSpPr>
        <p:spPr>
          <a:xfrm>
            <a:off x="4491360" y="4262400"/>
            <a:ext cx="58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Sever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15" name="Object 1"/>
          <p:cNvGraphicFramePr/>
          <p:nvPr/>
        </p:nvGraphicFramePr>
        <p:xfrm>
          <a:off x="2895480" y="2820960"/>
          <a:ext cx="6284880" cy="1555920"/>
        </p:xfrm>
        <a:graphic>
          <a:graphicData uri="http://schemas.openxmlformats.org/presentationml/2006/ole">
            <p:oleObj r:id="rId17" spid="">
              <p:embed/>
              <p:pic>
                <p:nvPicPr>
                  <p:cNvPr id="116" name="Object 1" descr=""/>
                  <p:cNvPicPr/>
                  <p:nvPr/>
                </p:nvPicPr>
                <p:blipFill>
                  <a:blip r:embed="rId18"/>
                  <a:stretch/>
                </p:blipFill>
                <p:spPr>
                  <a:xfrm>
                    <a:off x="2895480" y="2820960"/>
                    <a:ext cx="6284880" cy="1555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17" name="Text Box 95"/>
          <p:cNvSpPr/>
          <p:nvPr/>
        </p:nvSpPr>
        <p:spPr>
          <a:xfrm rot="16200000">
            <a:off x="-507600" y="3369960"/>
            <a:ext cx="1340640" cy="353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T</a:t>
            </a:r>
            <a:r>
              <a:rPr b="0" lang="en-GB" sz="8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H</a:t>
            </a: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1 cell frequencie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(% CD4+ or CD8- T cells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 Box 14"/>
          <p:cNvSpPr/>
          <p:nvPr/>
        </p:nvSpPr>
        <p:spPr>
          <a:xfrm>
            <a:off x="2220840" y="3016080"/>
            <a:ext cx="828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Healt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 Box 14"/>
          <p:cNvSpPr/>
          <p:nvPr/>
        </p:nvSpPr>
        <p:spPr>
          <a:xfrm>
            <a:off x="2214720" y="3129120"/>
            <a:ext cx="828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Asthm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Text Box 96"/>
          <p:cNvSpPr/>
          <p:nvPr/>
        </p:nvSpPr>
        <p:spPr>
          <a:xfrm>
            <a:off x="390240" y="4208400"/>
            <a:ext cx="545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PBM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Text Box 96"/>
          <p:cNvSpPr/>
          <p:nvPr/>
        </p:nvSpPr>
        <p:spPr>
          <a:xfrm>
            <a:off x="840960" y="4210200"/>
            <a:ext cx="615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Sputu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Text Box 96"/>
          <p:cNvSpPr/>
          <p:nvPr/>
        </p:nvSpPr>
        <p:spPr>
          <a:xfrm>
            <a:off x="1308600" y="4210200"/>
            <a:ext cx="418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BA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Text Box 96"/>
          <p:cNvSpPr/>
          <p:nvPr/>
        </p:nvSpPr>
        <p:spPr>
          <a:xfrm>
            <a:off x="1721520" y="4210200"/>
            <a:ext cx="560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Biops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Straight Connector 129"/>
          <p:cNvSpPr/>
          <p:nvPr/>
        </p:nvSpPr>
        <p:spPr>
          <a:xfrm>
            <a:off x="868320" y="4138560"/>
            <a:ext cx="0" cy="69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Straight Connector 130"/>
          <p:cNvSpPr/>
          <p:nvPr/>
        </p:nvSpPr>
        <p:spPr>
          <a:xfrm>
            <a:off x="1322280" y="4138560"/>
            <a:ext cx="0" cy="69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Straight Connector 131"/>
          <p:cNvSpPr/>
          <p:nvPr/>
        </p:nvSpPr>
        <p:spPr>
          <a:xfrm>
            <a:off x="1771560" y="4138560"/>
            <a:ext cx="0" cy="69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Straight Connector 75"/>
          <p:cNvSpPr/>
          <p:nvPr/>
        </p:nvSpPr>
        <p:spPr>
          <a:xfrm>
            <a:off x="3511440" y="987480"/>
            <a:ext cx="3733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Straight Connector 76"/>
          <p:cNvSpPr/>
          <p:nvPr/>
        </p:nvSpPr>
        <p:spPr>
          <a:xfrm>
            <a:off x="5508720" y="981000"/>
            <a:ext cx="3729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Straight Connector 77"/>
          <p:cNvSpPr/>
          <p:nvPr/>
        </p:nvSpPr>
        <p:spPr>
          <a:xfrm>
            <a:off x="7596360" y="981000"/>
            <a:ext cx="3729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Straight Connector 78"/>
          <p:cNvSpPr/>
          <p:nvPr/>
        </p:nvSpPr>
        <p:spPr>
          <a:xfrm>
            <a:off x="7596360" y="1042920"/>
            <a:ext cx="828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Box 73"/>
          <p:cNvSpPr/>
          <p:nvPr/>
        </p:nvSpPr>
        <p:spPr>
          <a:xfrm>
            <a:off x="3567960" y="69228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TextBox 73"/>
          <p:cNvSpPr/>
          <p:nvPr/>
        </p:nvSpPr>
        <p:spPr>
          <a:xfrm>
            <a:off x="7995600" y="79056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TextBox 73"/>
          <p:cNvSpPr/>
          <p:nvPr/>
        </p:nvSpPr>
        <p:spPr>
          <a:xfrm>
            <a:off x="7613280" y="717480"/>
            <a:ext cx="357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TextBox 73"/>
          <p:cNvSpPr/>
          <p:nvPr/>
        </p:nvSpPr>
        <p:spPr>
          <a:xfrm>
            <a:off x="5511600" y="692280"/>
            <a:ext cx="357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74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8-13T13:19:05Z</dcterms:created>
  <dc:creator>Hinks T.</dc:creator>
  <dc:description/>
  <dc:language>en-US</dc:language>
  <cp:lastModifiedBy>Hinks T.</cp:lastModifiedBy>
  <cp:lastPrinted>2013-09-25T09:00:55Z</cp:lastPrinted>
  <dcterms:modified xsi:type="dcterms:W3CDTF">2015-02-09T14:48:05Z</dcterms:modified>
  <cp:revision>277</cp:revision>
  <dc:subject/>
  <dc:title>PowerPoint Presentation</dc:title>
</cp:coreProperties>
</file>